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2" r:id="rId2"/>
    <p:sldId id="263" r:id="rId3"/>
  </p:sldIdLst>
  <p:sldSz cx="9144000" cy="6858000" type="screen4x3"/>
  <p:notesSz cx="7315200" cy="96012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964" autoAdjust="0"/>
    <p:restoredTop sz="94660"/>
  </p:normalViewPr>
  <p:slideViewPr>
    <p:cSldViewPr>
      <p:cViewPr varScale="1">
        <p:scale>
          <a:sx n="106" d="100"/>
          <a:sy n="106" d="100"/>
        </p:scale>
        <p:origin x="600" y="10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170717" cy="482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142775" y="0"/>
            <a:ext cx="3170717" cy="482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5235FAD-079F-4F89-98C5-FA70D2FF181A}" type="datetimeFigureOut">
              <a:rPr lang="en-US" smtClean="0"/>
              <a:t>12/12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497013" y="1200150"/>
            <a:ext cx="4321175" cy="32400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31179" y="4620981"/>
            <a:ext cx="5852843" cy="3779686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119145"/>
            <a:ext cx="3170717" cy="48205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142775" y="9119145"/>
            <a:ext cx="3170717" cy="48205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DA4D083-2EBD-4EEB-807C-1F3467DB30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057866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2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2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2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2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37011" y="6172200"/>
            <a:ext cx="9144000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NA measurement of leaf samples (White mold) by </a:t>
            </a:r>
            <a:r>
              <a:rPr lang="en-US" sz="1400" dirty="0" err="1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anoDrop</a:t>
            </a:r>
            <a:r>
              <a:rPr lang="en-US" sz="14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(ND-1000 Spectrophotometer)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: Control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; </a:t>
            </a:r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1: 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ock day 1; </a:t>
            </a:r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1: 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reated day 1;  M</a:t>
            </a:r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Mock day 3; T</a:t>
            </a:r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Treated day 3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 R</a:t>
            </a:r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sistant; </a:t>
            </a:r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: 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sceptible</a:t>
            </a:r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endParaRPr lang="en-US" sz="14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2012" y="381000"/>
            <a:ext cx="8413997" cy="5410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6177061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/>
        </p:nvSpPr>
        <p:spPr>
          <a:xfrm>
            <a:off x="2469742" y="2805164"/>
            <a:ext cx="4911636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         M1       T1         M3       T3         C          M1        T1       M3        T3      </a:t>
            </a:r>
          </a:p>
        </p:txBody>
      </p:sp>
      <p:sp>
        <p:nvSpPr>
          <p:cNvPr id="2" name="Rectangle 1"/>
          <p:cNvSpPr/>
          <p:nvPr/>
        </p:nvSpPr>
        <p:spPr>
          <a:xfrm>
            <a:off x="1960801" y="2806337"/>
            <a:ext cx="32092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en-US" sz="1200" dirty="0"/>
          </a:p>
        </p:txBody>
      </p:sp>
      <p:sp>
        <p:nvSpPr>
          <p:cNvPr id="4" name="Rectangle 3"/>
          <p:cNvSpPr/>
          <p:nvPr/>
        </p:nvSpPr>
        <p:spPr>
          <a:xfrm>
            <a:off x="609600" y="5859362"/>
            <a:ext cx="8077200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T-PCR amplification of White mold </a:t>
            </a:r>
            <a:r>
              <a:rPr lang="en-US" sz="14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DNA sample of cabbage </a:t>
            </a:r>
            <a:r>
              <a:rPr lang="en-US" sz="14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 (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NU-C-049</a:t>
            </a:r>
            <a:r>
              <a:rPr lang="en-US" sz="14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 and S (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NU-C-033</a:t>
            </a:r>
            <a:r>
              <a:rPr lang="en-US" sz="14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 lines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4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4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y </a:t>
            </a:r>
            <a:r>
              <a:rPr lang="en-US" sz="14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ctin1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rimer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en-US" sz="14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rassica </a:t>
            </a:r>
            <a:r>
              <a:rPr lang="en-US" sz="14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leracea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(</a:t>
            </a:r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Control; M1: Mock day 1; T1: Treated day 1;  M3: Mock day 3; T3: Treated day 3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</a:t>
            </a:r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Resistant; S: Susceptible</a:t>
            </a:r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M; 100 </a:t>
            </a:r>
            <a:r>
              <a:rPr lang="en-US" sz="1400" dirty="0" err="1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p</a:t>
            </a:r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DNA ladder</a:t>
            </a:r>
            <a:endParaRPr lang="en-US" sz="14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7" name="Rectangle 6"/>
          <p:cNvSpPr/>
          <p:nvPr/>
        </p:nvSpPr>
        <p:spPr>
          <a:xfrm>
            <a:off x="2897212" y="2306887"/>
            <a:ext cx="150073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 (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NU-C-049</a:t>
            </a:r>
            <a:r>
              <a:rPr lang="en-US" sz="14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endParaRPr lang="en-US" sz="1400" dirty="0"/>
          </a:p>
        </p:txBody>
      </p:sp>
      <p:sp>
        <p:nvSpPr>
          <p:cNvPr id="14" name="Rectangle 13"/>
          <p:cNvSpPr/>
          <p:nvPr/>
        </p:nvSpPr>
        <p:spPr>
          <a:xfrm>
            <a:off x="5323978" y="2306887"/>
            <a:ext cx="147989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 (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NU-C-033</a:t>
            </a:r>
            <a:r>
              <a:rPr lang="en-US" sz="14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endParaRPr lang="en-US" sz="1400" dirty="0"/>
          </a:p>
        </p:txBody>
      </p:sp>
      <p:sp>
        <p:nvSpPr>
          <p:cNvPr id="16" name="Left Brace 15"/>
          <p:cNvSpPr/>
          <p:nvPr/>
        </p:nvSpPr>
        <p:spPr>
          <a:xfrm rot="5400000">
            <a:off x="3488060" y="1655046"/>
            <a:ext cx="242836" cy="2057400"/>
          </a:xfrm>
          <a:prstGeom prst="leftBrac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Left Brace 16"/>
          <p:cNvSpPr/>
          <p:nvPr/>
        </p:nvSpPr>
        <p:spPr>
          <a:xfrm rot="5400000">
            <a:off x="5942506" y="1667480"/>
            <a:ext cx="242836" cy="2057400"/>
          </a:xfrm>
          <a:prstGeom prst="leftBrac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28800" y="3048000"/>
            <a:ext cx="5552578" cy="1399032"/>
          </a:xfrm>
          <a:prstGeom prst="rect">
            <a:avLst/>
          </a:prstGeom>
        </p:spPr>
      </p:pic>
      <p:sp>
        <p:nvSpPr>
          <p:cNvPr id="9" name="Rectangle 8"/>
          <p:cNvSpPr/>
          <p:nvPr/>
        </p:nvSpPr>
        <p:spPr>
          <a:xfrm>
            <a:off x="904378" y="3562850"/>
            <a:ext cx="87075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ctin 1</a:t>
            </a:r>
            <a:endParaRPr lang="en-US" i="1" dirty="0"/>
          </a:p>
        </p:txBody>
      </p:sp>
    </p:spTree>
    <p:extLst>
      <p:ext uri="{BB962C8B-B14F-4D97-AF65-F5344CB8AC3E}">
        <p14:creationId xmlns:p14="http://schemas.microsoft.com/office/powerpoint/2010/main" val="9840386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010</TotalTime>
  <Words>142</Words>
  <Application>Microsoft Office PowerPoint</Application>
  <PresentationFormat>On-screen Show (4:3)</PresentationFormat>
  <Paragraphs>7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Times New Roman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usuf</dc:creator>
  <cp:lastModifiedBy>user</cp:lastModifiedBy>
  <cp:revision>44</cp:revision>
  <cp:lastPrinted>2018-12-01T06:55:11Z</cp:lastPrinted>
  <dcterms:created xsi:type="dcterms:W3CDTF">2006-08-16T00:00:00Z</dcterms:created>
  <dcterms:modified xsi:type="dcterms:W3CDTF">2018-12-13T01:28:17Z</dcterms:modified>
</cp:coreProperties>
</file>